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9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6" autoAdjust="0"/>
    <p:restoredTop sz="92986" autoAdjust="0"/>
  </p:normalViewPr>
  <p:slideViewPr>
    <p:cSldViewPr snapToGrid="0" snapToObjects="1">
      <p:cViewPr varScale="1">
        <p:scale>
          <a:sx n="59" d="100"/>
          <a:sy n="59" d="100"/>
        </p:scale>
        <p:origin x="2892" y="7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63235-826B-4DBE-BF6E-0C185A76ABA3}" type="datetimeFigureOut">
              <a:rPr lang="zh-CN" altLang="en-US" smtClean="0"/>
              <a:pPr/>
              <a:t>2018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0AFE5-DE01-4638-B01A-C45FD2F995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38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75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766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404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041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246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463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361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779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033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832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610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005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39" t="6493" r="9625" b="7990"/>
          <a:stretch/>
        </p:blipFill>
        <p:spPr>
          <a:xfrm>
            <a:off x="2888946" y="722798"/>
            <a:ext cx="4091352" cy="4607235"/>
          </a:xfrm>
        </p:spPr>
      </p:pic>
      <p:sp>
        <p:nvSpPr>
          <p:cNvPr id="11" name="文本框 10"/>
          <p:cNvSpPr txBox="1"/>
          <p:nvPr/>
        </p:nvSpPr>
        <p:spPr>
          <a:xfrm>
            <a:off x="1313128" y="1087718"/>
            <a:ext cx="191538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 hormone signal transduc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458669" y="1275451"/>
            <a:ext cx="191538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Ubiquitin mediated proteoly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461231" y="1444329"/>
            <a:ext cx="187093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acyl-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NA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190367" y="1824650"/>
            <a:ext cx="229449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steine and methionine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276715" y="1622980"/>
            <a:ext cx="196676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some biogenesis in eukaryote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700478" y="2161566"/>
            <a:ext cx="156423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hocyanin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333413" y="2259031"/>
            <a:ext cx="20764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oquinolin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kaloid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520324" y="2353770"/>
            <a:ext cx="20764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ylpropanoid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21336" y="2439007"/>
            <a:ext cx="268476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opane,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peridin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yridine alkaloid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628672" y="3064254"/>
            <a:ext cx="20764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ntose phosphate pathwa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918878" y="3155720"/>
            <a:ext cx="20764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ruvate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487403" y="3244147"/>
            <a:ext cx="20764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rch and sucrose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672213" y="3433243"/>
            <a:ext cx="20764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idative phosphoryla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2043949" y="3515449"/>
            <a:ext cx="20764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lfur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1757231" y="4237123"/>
            <a:ext cx="149485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lipid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1791073" y="4862543"/>
            <a:ext cx="148246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otenoid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2001378" y="4966604"/>
            <a:ext cx="148246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atin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6" name="组合 55"/>
          <p:cNvGrpSpPr/>
          <p:nvPr/>
        </p:nvGrpSpPr>
        <p:grpSpPr>
          <a:xfrm>
            <a:off x="781033" y="638524"/>
            <a:ext cx="2913366" cy="4644283"/>
            <a:chOff x="708539" y="301548"/>
            <a:chExt cx="2642953" cy="4213209"/>
          </a:xfrm>
        </p:grpSpPr>
        <p:sp>
          <p:nvSpPr>
            <p:cNvPr id="5" name="文本框 4"/>
            <p:cNvSpPr txBox="1"/>
            <p:nvPr/>
          </p:nvSpPr>
          <p:spPr>
            <a:xfrm>
              <a:off x="2081730" y="301548"/>
              <a:ext cx="768485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docytosi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091461" y="390528"/>
              <a:ext cx="768485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oxisome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584401" y="474090"/>
              <a:ext cx="1191637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gulation of autophagy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864074" y="556618"/>
              <a:ext cx="946013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C transporter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038435" y="627176"/>
              <a:ext cx="1737603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atidylinositol signaling syste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781261" y="791642"/>
              <a:ext cx="2048282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 processing in endoplasmic reticulu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764369" y="956108"/>
              <a:ext cx="1111385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 excision repair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768155" y="1289315"/>
              <a:ext cx="2044458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anine, aspartate and glutamate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982427" y="1107012"/>
              <a:ext cx="806585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 transport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904346" y="1451042"/>
              <a:ext cx="1883718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ine, serine and threonine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1517753" y="1524634"/>
              <a:ext cx="1280987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enylalanine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728388" y="1594877"/>
              <a:ext cx="1121827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yrosine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708539" y="2013653"/>
              <a:ext cx="2115498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ino sugar and nucleotide sugar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547739" y="2102296"/>
              <a:ext cx="1258285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trate cycle (TCA cycle)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1696884" y="2177873"/>
              <a:ext cx="1082400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lactose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1396337" y="2265115"/>
              <a:ext cx="1392675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olysis / Gluconeogenesi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902959" y="2341127"/>
              <a:ext cx="1883718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lyoxylate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icarboxylate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906893" y="2420256"/>
              <a:ext cx="1883718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ntose and </a:t>
              </a:r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lucuronate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terconversion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785798" y="2750499"/>
              <a:ext cx="2022670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n fixation in photosynthetic organism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1467774" y="3080231"/>
              <a:ext cx="1883718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osynthesis of amino acid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1227921" y="2986990"/>
              <a:ext cx="1883718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Oxocarboxylic acid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1808503" y="3163207"/>
              <a:ext cx="984603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n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1038435" y="3318283"/>
              <a:ext cx="1883718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osynthesis of unsaturated fatty acid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697899" y="3236514"/>
              <a:ext cx="1091113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tty 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id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668001" y="3407545"/>
              <a:ext cx="1158489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ther lipid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1691491" y="3482176"/>
              <a:ext cx="1142274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tty acid degradation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1250220" y="3638689"/>
              <a:ext cx="1625534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erophospholipid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1579927" y="3731771"/>
              <a:ext cx="1321545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hingolipid 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1276463" y="3810384"/>
              <a:ext cx="1625534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pha-</a:t>
              </a:r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inolenic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1633041" y="3974459"/>
              <a:ext cx="1178977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tathione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1399085" y="3886060"/>
              <a:ext cx="1451130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anoamino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1590293" y="4049825"/>
              <a:ext cx="1287900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a-Alanine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1534948" y="4307851"/>
              <a:ext cx="1344862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nt-pathogen interaction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8" name="文本框 57"/>
          <p:cNvSpPr txBox="1"/>
          <p:nvPr/>
        </p:nvSpPr>
        <p:spPr>
          <a:xfrm>
            <a:off x="3425522" y="638513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3711150" y="743483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3269148" y="823008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3276198" y="917044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4023918" y="997539"/>
            <a:ext cx="32349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5506788" y="1087718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3574509" y="1196118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3420436" y="1289725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3267880" y="1371465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3274890" y="1453149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3710595" y="1549474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3417503" y="1651417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3262811" y="1721413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3570897" y="1825343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3415841" y="1906892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3714613" y="1999826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3267999" y="2090772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3104765" y="2175047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/>
          <p:cNvSpPr txBox="1"/>
          <p:nvPr/>
        </p:nvSpPr>
        <p:spPr>
          <a:xfrm>
            <a:off x="3272439" y="2257291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/>
          <p:cNvSpPr txBox="1"/>
          <p:nvPr/>
        </p:nvSpPr>
        <p:spPr>
          <a:xfrm>
            <a:off x="3869836" y="2349706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/>
          <p:cNvSpPr txBox="1"/>
          <p:nvPr/>
        </p:nvSpPr>
        <p:spPr>
          <a:xfrm>
            <a:off x="3417532" y="2442735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/>
          <p:cNvSpPr txBox="1"/>
          <p:nvPr/>
        </p:nvSpPr>
        <p:spPr>
          <a:xfrm>
            <a:off x="3413051" y="2534606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3267829" y="2629078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3265376" y="2710014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4010280" y="2795153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3855107" y="2900856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3408559" y="2976439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3558385" y="3060912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85"/>
          <p:cNvSpPr txBox="1"/>
          <p:nvPr/>
        </p:nvSpPr>
        <p:spPr>
          <a:xfrm>
            <a:off x="3714213" y="3156056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>
            <a:off x="3872753" y="3241996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3710160" y="3359808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3265312" y="3430596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3420523" y="3513553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3119198" y="3608265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3865309" y="3704384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4761577" y="3798798"/>
            <a:ext cx="35201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3268911" y="3894175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94"/>
          <p:cNvSpPr txBox="1"/>
          <p:nvPr/>
        </p:nvSpPr>
        <p:spPr>
          <a:xfrm>
            <a:off x="3264858" y="3977678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95"/>
          <p:cNvSpPr txBox="1"/>
          <p:nvPr/>
        </p:nvSpPr>
        <p:spPr>
          <a:xfrm>
            <a:off x="3261148" y="4071110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/>
          <p:cNvSpPr txBox="1"/>
          <p:nvPr/>
        </p:nvSpPr>
        <p:spPr>
          <a:xfrm>
            <a:off x="3258508" y="4156399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文本框 97"/>
          <p:cNvSpPr txBox="1"/>
          <p:nvPr/>
        </p:nvSpPr>
        <p:spPr>
          <a:xfrm>
            <a:off x="3714620" y="4234249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4013167" y="4340357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7246979" y="5783133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100"/>
          <p:cNvSpPr txBox="1"/>
          <p:nvPr/>
        </p:nvSpPr>
        <p:spPr>
          <a:xfrm>
            <a:off x="3258774" y="4430787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本框 101"/>
          <p:cNvSpPr txBox="1"/>
          <p:nvPr/>
        </p:nvSpPr>
        <p:spPr>
          <a:xfrm>
            <a:off x="3266199" y="4513159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文本框 102"/>
          <p:cNvSpPr txBox="1"/>
          <p:nvPr/>
        </p:nvSpPr>
        <p:spPr>
          <a:xfrm>
            <a:off x="3423130" y="4605480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4856496" y="5031275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文本框 104"/>
          <p:cNvSpPr txBox="1"/>
          <p:nvPr/>
        </p:nvSpPr>
        <p:spPr>
          <a:xfrm>
            <a:off x="3264324" y="4686264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3423297" y="4788595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文本框 106"/>
          <p:cNvSpPr txBox="1"/>
          <p:nvPr/>
        </p:nvSpPr>
        <p:spPr>
          <a:xfrm>
            <a:off x="3268066" y="4873051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文本框 107"/>
          <p:cNvSpPr txBox="1"/>
          <p:nvPr/>
        </p:nvSpPr>
        <p:spPr>
          <a:xfrm>
            <a:off x="3425295" y="4964947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文本框 108"/>
          <p:cNvSpPr txBox="1"/>
          <p:nvPr/>
        </p:nvSpPr>
        <p:spPr>
          <a:xfrm>
            <a:off x="5063722" y="5033456"/>
            <a:ext cx="3985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5820662" y="713037"/>
            <a:ext cx="1590385" cy="261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process</a:t>
            </a:r>
            <a:endParaRPr lang="zh-CN" altLang="en-US" sz="110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4559459" y="958209"/>
            <a:ext cx="2376137" cy="261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2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vironmental information processing</a:t>
            </a:r>
            <a:endParaRPr lang="zh-CN" altLang="en-US" sz="110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/>
          <p:cNvSpPr txBox="1"/>
          <p:nvPr/>
        </p:nvSpPr>
        <p:spPr>
          <a:xfrm>
            <a:off x="4958893" y="1426356"/>
            <a:ext cx="2376137" cy="261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tic information processing</a:t>
            </a:r>
            <a:endParaRPr lang="zh-CN" altLang="en-US" sz="110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文本框 112"/>
          <p:cNvSpPr txBox="1"/>
          <p:nvPr/>
        </p:nvSpPr>
        <p:spPr>
          <a:xfrm>
            <a:off x="6034439" y="3244148"/>
            <a:ext cx="2376137" cy="261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sm</a:t>
            </a:r>
            <a:endParaRPr lang="zh-CN" altLang="en-US" sz="110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文本框 114"/>
          <p:cNvSpPr txBox="1"/>
          <p:nvPr/>
        </p:nvSpPr>
        <p:spPr>
          <a:xfrm>
            <a:off x="5636808" y="5007793"/>
            <a:ext cx="2376137" cy="261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ganismal system</a:t>
            </a:r>
            <a:endParaRPr lang="zh-CN" altLang="en-US" sz="110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文本框 116"/>
          <p:cNvSpPr txBox="1"/>
          <p:nvPr/>
        </p:nvSpPr>
        <p:spPr>
          <a:xfrm>
            <a:off x="4664181" y="5221078"/>
            <a:ext cx="41962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%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文本框 116"/>
          <p:cNvSpPr txBox="1"/>
          <p:nvPr/>
        </p:nvSpPr>
        <p:spPr>
          <a:xfrm>
            <a:off x="6615762" y="5231266"/>
            <a:ext cx="41962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%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文本框 117"/>
          <p:cNvSpPr txBox="1"/>
          <p:nvPr/>
        </p:nvSpPr>
        <p:spPr>
          <a:xfrm>
            <a:off x="4104414" y="5345339"/>
            <a:ext cx="2046471" cy="261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notated genes</a:t>
            </a:r>
            <a:endParaRPr lang="zh-CN" altLang="en-US" sz="110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文本框 118"/>
          <p:cNvSpPr txBox="1"/>
          <p:nvPr/>
        </p:nvSpPr>
        <p:spPr>
          <a:xfrm>
            <a:off x="2778257" y="5232328"/>
            <a:ext cx="41962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%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文本框 119"/>
          <p:cNvSpPr txBox="1"/>
          <p:nvPr/>
        </p:nvSpPr>
        <p:spPr>
          <a:xfrm>
            <a:off x="3754447" y="5231266"/>
            <a:ext cx="41962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%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文本框 116"/>
          <p:cNvSpPr txBox="1"/>
          <p:nvPr/>
        </p:nvSpPr>
        <p:spPr>
          <a:xfrm>
            <a:off x="5657844" y="5217503"/>
            <a:ext cx="41962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%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TextBox 3"/>
          <p:cNvSpPr txBox="1"/>
          <p:nvPr/>
        </p:nvSpPr>
        <p:spPr>
          <a:xfrm flipH="1">
            <a:off x="70545" y="304894"/>
            <a:ext cx="130241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S10</a:t>
            </a:r>
            <a:endParaRPr lang="en-US" sz="1323" b="1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  <p:sp>
        <p:nvSpPr>
          <p:cNvPr id="124" name="文本框 123"/>
          <p:cNvSpPr txBox="1"/>
          <p:nvPr/>
        </p:nvSpPr>
        <p:spPr>
          <a:xfrm>
            <a:off x="3355830" y="9321383"/>
            <a:ext cx="17107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文本框 124"/>
          <p:cNvSpPr txBox="1"/>
          <p:nvPr/>
        </p:nvSpPr>
        <p:spPr>
          <a:xfrm>
            <a:off x="3964812" y="9317278"/>
            <a:ext cx="17107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文本框 125"/>
          <p:cNvSpPr txBox="1"/>
          <p:nvPr/>
        </p:nvSpPr>
        <p:spPr>
          <a:xfrm>
            <a:off x="4585368" y="9327278"/>
            <a:ext cx="17107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文本框 127"/>
          <p:cNvSpPr txBox="1"/>
          <p:nvPr/>
        </p:nvSpPr>
        <p:spPr>
          <a:xfrm>
            <a:off x="3640532" y="9529117"/>
            <a:ext cx="1090267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ch factor</a:t>
            </a:r>
            <a:endParaRPr lang="zh-CN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0" name="图片 129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29" t="3532" r="12907" b="4724"/>
          <a:stretch/>
        </p:blipFill>
        <p:spPr>
          <a:xfrm>
            <a:off x="2910316" y="5753453"/>
            <a:ext cx="2607195" cy="3638962"/>
          </a:xfrm>
          <a:prstGeom prst="rect">
            <a:avLst/>
          </a:prstGeom>
        </p:spPr>
      </p:pic>
      <p:sp>
        <p:nvSpPr>
          <p:cNvPr id="131" name="文本框 130"/>
          <p:cNvSpPr txBox="1"/>
          <p:nvPr/>
        </p:nvSpPr>
        <p:spPr>
          <a:xfrm>
            <a:off x="1914943" y="5742495"/>
            <a:ext cx="148246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atin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文本框 131"/>
          <p:cNvSpPr txBox="1"/>
          <p:nvPr/>
        </p:nvSpPr>
        <p:spPr>
          <a:xfrm>
            <a:off x="347403" y="5930903"/>
            <a:ext cx="28755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opane,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peridin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yridine alkaloid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文本框 132"/>
          <p:cNvSpPr txBox="1"/>
          <p:nvPr/>
        </p:nvSpPr>
        <p:spPr>
          <a:xfrm>
            <a:off x="1962375" y="6089224"/>
            <a:ext cx="111327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lfur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文本框 133"/>
          <p:cNvSpPr txBox="1"/>
          <p:nvPr/>
        </p:nvSpPr>
        <p:spPr>
          <a:xfrm>
            <a:off x="1605011" y="6266889"/>
            <a:ext cx="150187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-pathogen interac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文本框 134"/>
          <p:cNvSpPr txBox="1"/>
          <p:nvPr/>
        </p:nvSpPr>
        <p:spPr>
          <a:xfrm>
            <a:off x="1248135" y="6445605"/>
            <a:ext cx="184007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 hormone signal transduc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文本框 135"/>
          <p:cNvSpPr txBox="1"/>
          <p:nvPr/>
        </p:nvSpPr>
        <p:spPr>
          <a:xfrm>
            <a:off x="1083714" y="6624321"/>
            <a:ext cx="204069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atidylinositol signaling syste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文本框 137"/>
          <p:cNvSpPr txBox="1"/>
          <p:nvPr/>
        </p:nvSpPr>
        <p:spPr>
          <a:xfrm>
            <a:off x="1423279" y="6792314"/>
            <a:ext cx="163724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ylpropanoid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文本框 138"/>
          <p:cNvSpPr txBox="1"/>
          <p:nvPr/>
        </p:nvSpPr>
        <p:spPr>
          <a:xfrm>
            <a:off x="1580549" y="6971030"/>
            <a:ext cx="142672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nylalanine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文本框 139"/>
          <p:cNvSpPr txBox="1"/>
          <p:nvPr/>
        </p:nvSpPr>
        <p:spPr>
          <a:xfrm>
            <a:off x="924548" y="7523480"/>
            <a:ext cx="230881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ntose and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uronat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rconversion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文本框 140"/>
          <p:cNvSpPr txBox="1"/>
          <p:nvPr/>
        </p:nvSpPr>
        <p:spPr>
          <a:xfrm>
            <a:off x="2238222" y="7146172"/>
            <a:ext cx="102257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oxisome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文本框 141"/>
          <p:cNvSpPr txBox="1"/>
          <p:nvPr/>
        </p:nvSpPr>
        <p:spPr>
          <a:xfrm>
            <a:off x="1532476" y="7324888"/>
            <a:ext cx="145037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ntose phosphate pathwa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文本框 142"/>
          <p:cNvSpPr txBox="1"/>
          <p:nvPr/>
        </p:nvSpPr>
        <p:spPr>
          <a:xfrm>
            <a:off x="1264109" y="7702195"/>
            <a:ext cx="179640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oquinolin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kaloid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文本框 143"/>
          <p:cNvSpPr txBox="1"/>
          <p:nvPr/>
        </p:nvSpPr>
        <p:spPr>
          <a:xfrm>
            <a:off x="928120" y="7870189"/>
            <a:ext cx="230881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oxylat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carboxylat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文本框 144"/>
          <p:cNvSpPr txBox="1"/>
          <p:nvPr/>
        </p:nvSpPr>
        <p:spPr>
          <a:xfrm>
            <a:off x="1460696" y="8038182"/>
            <a:ext cx="230881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olysis / Gluconeogen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文本框 145"/>
          <p:cNvSpPr txBox="1"/>
          <p:nvPr/>
        </p:nvSpPr>
        <p:spPr>
          <a:xfrm>
            <a:off x="1296275" y="8227621"/>
            <a:ext cx="230881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phospholipid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文本框 146"/>
          <p:cNvSpPr txBox="1"/>
          <p:nvPr/>
        </p:nvSpPr>
        <p:spPr>
          <a:xfrm>
            <a:off x="1915542" y="8755529"/>
            <a:ext cx="112443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bon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文本框 147"/>
          <p:cNvSpPr txBox="1"/>
          <p:nvPr/>
        </p:nvSpPr>
        <p:spPr>
          <a:xfrm>
            <a:off x="1674601" y="8389218"/>
            <a:ext cx="165521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lipid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abol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文本框 149"/>
          <p:cNvSpPr txBox="1"/>
          <p:nvPr/>
        </p:nvSpPr>
        <p:spPr>
          <a:xfrm>
            <a:off x="1446933" y="8579499"/>
            <a:ext cx="167226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882" dirty="0"/>
              <a:t>Cyanoamino acid metabolism</a:t>
            </a:r>
          </a:p>
        </p:txBody>
      </p:sp>
      <p:sp>
        <p:nvSpPr>
          <p:cNvPr id="151" name="文本框 150"/>
          <p:cNvSpPr txBox="1"/>
          <p:nvPr/>
        </p:nvSpPr>
        <p:spPr>
          <a:xfrm>
            <a:off x="778000" y="8934245"/>
            <a:ext cx="22798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bon fixation in photosynthetic organism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文本框 151"/>
          <p:cNvSpPr txBox="1"/>
          <p:nvPr/>
        </p:nvSpPr>
        <p:spPr>
          <a:xfrm>
            <a:off x="2003893" y="9123878"/>
            <a:ext cx="112443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C transporter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文本框 263"/>
          <p:cNvSpPr txBox="1"/>
          <p:nvPr/>
        </p:nvSpPr>
        <p:spPr>
          <a:xfrm>
            <a:off x="5471164" y="8080392"/>
            <a:ext cx="77024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文本框 263"/>
          <p:cNvSpPr txBox="1"/>
          <p:nvPr/>
        </p:nvSpPr>
        <p:spPr>
          <a:xfrm>
            <a:off x="5472486" y="7669197"/>
            <a:ext cx="77024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文本框 263"/>
          <p:cNvSpPr txBox="1"/>
          <p:nvPr/>
        </p:nvSpPr>
        <p:spPr>
          <a:xfrm>
            <a:off x="5473887" y="7941015"/>
            <a:ext cx="77024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文本框 263"/>
          <p:cNvSpPr txBox="1"/>
          <p:nvPr/>
        </p:nvSpPr>
        <p:spPr>
          <a:xfrm>
            <a:off x="5253277" y="7387894"/>
            <a:ext cx="99085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value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文本框 263"/>
          <p:cNvSpPr txBox="1"/>
          <p:nvPr/>
        </p:nvSpPr>
        <p:spPr>
          <a:xfrm>
            <a:off x="5468060" y="7548052"/>
            <a:ext cx="77024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文本框 263"/>
          <p:cNvSpPr txBox="1"/>
          <p:nvPr/>
        </p:nvSpPr>
        <p:spPr>
          <a:xfrm>
            <a:off x="5472999" y="7803326"/>
            <a:ext cx="77024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1" name="图片 16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65213" y="8432043"/>
            <a:ext cx="153010" cy="577266"/>
          </a:xfrm>
          <a:prstGeom prst="rect">
            <a:avLst/>
          </a:prstGeom>
        </p:spPr>
      </p:pic>
      <p:sp>
        <p:nvSpPr>
          <p:cNvPr id="162" name="文本框 263"/>
          <p:cNvSpPr txBox="1"/>
          <p:nvPr/>
        </p:nvSpPr>
        <p:spPr>
          <a:xfrm>
            <a:off x="5298710" y="8239715"/>
            <a:ext cx="99085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ene_number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文本框 263"/>
          <p:cNvSpPr txBox="1"/>
          <p:nvPr/>
        </p:nvSpPr>
        <p:spPr>
          <a:xfrm>
            <a:off x="5441718" y="8399664"/>
            <a:ext cx="33543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文本框 263"/>
          <p:cNvSpPr txBox="1"/>
          <p:nvPr/>
        </p:nvSpPr>
        <p:spPr>
          <a:xfrm>
            <a:off x="5448467" y="8526090"/>
            <a:ext cx="33543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文本框 263"/>
          <p:cNvSpPr txBox="1"/>
          <p:nvPr/>
        </p:nvSpPr>
        <p:spPr>
          <a:xfrm>
            <a:off x="5433048" y="8672877"/>
            <a:ext cx="33543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文本框 263"/>
          <p:cNvSpPr txBox="1"/>
          <p:nvPr/>
        </p:nvSpPr>
        <p:spPr>
          <a:xfrm>
            <a:off x="5445371" y="8809634"/>
            <a:ext cx="33543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6247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3</TotalTime>
  <Words>307</Words>
  <Application>Microsoft Office PowerPoint</Application>
  <PresentationFormat>自定义</PresentationFormat>
  <Paragraphs>14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zyangyan</cp:lastModifiedBy>
  <cp:revision>159</cp:revision>
  <dcterms:created xsi:type="dcterms:W3CDTF">2017-02-03T22:12:08Z</dcterms:created>
  <dcterms:modified xsi:type="dcterms:W3CDTF">2018-08-23T04:46:15Z</dcterms:modified>
</cp:coreProperties>
</file>